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0" d="100"/>
          <a:sy n="40" d="100"/>
        </p:scale>
        <p:origin x="-1122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43CCA-650E-4D99-A3EB-707059A30EC0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5263E-079C-4D86-83E5-6840ACEDDC7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43CCA-650E-4D99-A3EB-707059A30EC0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5263E-079C-4D86-83E5-6840ACEDDC7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43CCA-650E-4D99-A3EB-707059A30EC0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5263E-079C-4D86-83E5-6840ACEDDC7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43CCA-650E-4D99-A3EB-707059A30EC0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5263E-079C-4D86-83E5-6840ACEDDC7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43CCA-650E-4D99-A3EB-707059A30EC0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5263E-079C-4D86-83E5-6840ACEDDC7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43CCA-650E-4D99-A3EB-707059A30EC0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5263E-079C-4D86-83E5-6840ACEDDC7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43CCA-650E-4D99-A3EB-707059A30EC0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5263E-079C-4D86-83E5-6840ACEDDC7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43CCA-650E-4D99-A3EB-707059A30EC0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5263E-079C-4D86-83E5-6840ACEDDC7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43CCA-650E-4D99-A3EB-707059A30EC0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5263E-079C-4D86-83E5-6840ACEDDC7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43CCA-650E-4D99-A3EB-707059A30EC0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5263E-079C-4D86-83E5-6840ACEDDC7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543CCA-650E-4D99-A3EB-707059A30EC0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5263E-079C-4D86-83E5-6840ACEDDC7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543CCA-650E-4D99-A3EB-707059A30EC0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55263E-079C-4D86-83E5-6840ACEDDC73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philip.roberts@ucr.edu" TargetMode="External"/><Relationship Id="rId2" Type="http://schemas.openxmlformats.org/officeDocument/2006/relationships/hyperlink" Target="mailto:timothy.close@ucr.edu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914400" y="1600200"/>
            <a:ext cx="7166449" cy="19389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enetic Mapping, Synteny and Physical Location of Two Loci for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usarium oxysporum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f.sp.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racheiphilum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Race 4 Resistance in Cowpea [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Vign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unguiculat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(L.) 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Walp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]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olecular Breeding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Authors and Affiliations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arti O. Pottorff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uojing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Li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2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Jeffery D. Ehlers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,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Timothy J. Close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d Philip A. Roberts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partment of Botany &amp; Plant Sciences, University of California Riverside, Riverside, CA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2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Zhejiang Academy of Agricultural Sciences, Hangzhou, P.R. China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3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Bill &amp; Melinda Gates Foundation, Seattle, Washington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4 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partment of Nematology, University of California Riverside, Riverside, CA, U.S.A.</a:t>
            </a:r>
            <a:endParaRPr kumimoji="0" 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orresponding author: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  <a:hlinkClick r:id="rId2"/>
              </a:rPr>
              <a:t>timothy.close@ucr.edu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nd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  <a:hlinkClick r:id="rId3"/>
              </a:rPr>
              <a:t>philip.roberts@ucr.edu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2400300" y="1851660"/>
          <a:ext cx="4343400" cy="3154680"/>
        </p:xfrm>
        <a:graphic>
          <a:graphicData uri="http://schemas.openxmlformats.org/drawingml/2006/table">
            <a:tbl>
              <a:tblPr/>
              <a:tblGrid>
                <a:gridCol w="802640"/>
                <a:gridCol w="1355725"/>
                <a:gridCol w="1003935"/>
                <a:gridCol w="590550"/>
                <a:gridCol w="590550"/>
              </a:tblGrid>
              <a:tr h="0">
                <a:tc gridSpan="5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Online Resource 6. QTL analysis of </a:t>
                      </a:r>
                      <a:r>
                        <a:rPr lang="en-US" sz="1000" i="1">
                          <a:latin typeface="Times New Roman"/>
                          <a:ea typeface="Calibri"/>
                          <a:cs typeface="Times New Roman"/>
                        </a:rPr>
                        <a:t>Fot4-2</a:t>
                      </a: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 in CB27 x IT82E-18/Big Buff.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Experiment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Phenotype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QTL analysis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1_0352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1_1087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2009a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Wilt/stunting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MQM LOD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10.66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9.92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Wilt/stunting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R</a:t>
                      </a:r>
                      <a:r>
                        <a:rPr lang="en-US" sz="1000" baseline="30000"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27.1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25.5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Wilt/stunting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KW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SimSun"/>
                          <a:cs typeface="Times New Roman"/>
                        </a:rPr>
                        <a:t>39.42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SimSun"/>
                          <a:cs typeface="Times New Roman"/>
                        </a:rPr>
                        <a:t>36.57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Wilt/stunting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p-value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SimSun"/>
                          <a:cs typeface="Times New Roman"/>
                        </a:rPr>
                        <a:t>0.0001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SimSun"/>
                          <a:cs typeface="Times New Roman"/>
                        </a:rPr>
                        <a:t>0.0001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Vascular discoloration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MQM LOD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9.45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8.96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Vascular discoloration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R</a:t>
                      </a:r>
                      <a:r>
                        <a:rPr lang="en-US" sz="1000" baseline="30000"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24.5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23.4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Vascular discoloration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KW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SimSun"/>
                          <a:cs typeface="Times New Roman"/>
                        </a:rPr>
                        <a:t>32.81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SimSun"/>
                          <a:cs typeface="Times New Roman"/>
                        </a:rPr>
                        <a:t>30.74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Vascular discoloration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p-value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SimSun"/>
                          <a:cs typeface="Times New Roman"/>
                        </a:rPr>
                        <a:t>0.0001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SimSun"/>
                          <a:cs typeface="Times New Roman"/>
                        </a:rPr>
                        <a:t>0.0001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2009b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Wilt/stunting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MQM LOD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7.39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6.82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Wilt/stunting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R</a:t>
                      </a:r>
                      <a:r>
                        <a:rPr lang="en-US" sz="1000" baseline="30000"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 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19.6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18.2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Wilt/stunting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KW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SimSun"/>
                          <a:cs typeface="Times New Roman"/>
                        </a:rPr>
                        <a:t>30.31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SimSun"/>
                          <a:cs typeface="Times New Roman"/>
                        </a:rPr>
                        <a:t>27.84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Wilt/stunting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p-value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SimSun"/>
                          <a:cs typeface="Times New Roman"/>
                        </a:rPr>
                        <a:t>0.0001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SimSun"/>
                          <a:cs typeface="Times New Roman"/>
                        </a:rPr>
                        <a:t>0.0001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Vascular discoloration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MQM LOD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7.11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6.72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Vascular discoloration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R</a:t>
                      </a:r>
                      <a:r>
                        <a:rPr lang="en-US" sz="1000" baseline="30000">
                          <a:latin typeface="Times New Roman"/>
                          <a:ea typeface="Calibri"/>
                          <a:cs typeface="Times New Roman"/>
                        </a:rPr>
                        <a:t>2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18.9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18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Vascular discoloration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KW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SimSun"/>
                          <a:cs typeface="Times New Roman"/>
                        </a:rPr>
                        <a:t>26.00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SimSun"/>
                          <a:cs typeface="Times New Roman"/>
                        </a:rPr>
                        <a:t>24.16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Vascular discoloration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Times New Roman"/>
                        </a:rPr>
                        <a:t>p-value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SimSun"/>
                          <a:cs typeface="Times New Roman"/>
                        </a:rPr>
                        <a:t>0.0001</a:t>
                      </a:r>
                      <a:endParaRPr lang="en-US" sz="11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SimSun"/>
                          <a:cs typeface="Times New Roman"/>
                        </a:rPr>
                        <a:t>0.0001</a:t>
                      </a:r>
                      <a:endParaRPr lang="en-US" sz="11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73025" marR="73025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0</Words>
  <Application>Microsoft Office PowerPoint</Application>
  <PresentationFormat>On-screen Show (4:3)</PresentationFormat>
  <Paragraphs>8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rti</dc:creator>
  <cp:lastModifiedBy>Marti</cp:lastModifiedBy>
  <cp:revision>1</cp:revision>
  <dcterms:created xsi:type="dcterms:W3CDTF">2013-11-13T12:23:40Z</dcterms:created>
  <dcterms:modified xsi:type="dcterms:W3CDTF">2013-11-13T12:24:34Z</dcterms:modified>
</cp:coreProperties>
</file>